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343" r:id="rId5"/>
    <p:sldId id="344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126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9460F9-FCDB-4679-9D2C-6DC6A36CC2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DD42627-8F83-43EB-9EE8-83598A56EC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207193-9C80-4300-8BD3-5ECACFCA0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527968-AA0F-456C-BA33-BA06423ED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FBEFAE-43A4-4A52-AE7E-6803AEE7A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75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36F45D-DC60-4348-8F89-06E1AB586E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822C9ED-F2C8-49D5-A4D8-BC32D5E16E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FD94C8-3EAB-46AD-996C-E6F8E1997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5ECB5D-A6E6-46E8-B587-558EF3F4E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32C690-C31B-4F4C-A5EC-48ED249EE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256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FA803B5-F4F8-415E-8E62-CBAE9B770A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D0832D-37AA-423B-A79A-7541227BF0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D175A2-0147-4D63-AA78-862B077E2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4F02C1-D89B-4453-A06A-2DB017101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6A3BD6-BF8B-499D-957D-BE2DA27F2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274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9F84C7-85BB-480D-9AC8-C6D8A78253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C02F795-8475-4FAB-9A58-E194DACAF8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3B2609-E31A-4915-A1FF-3ED9A3D33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DD3E44-C140-4A2A-B8B5-A0DD9F83F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7C790F-E424-4FAD-9CEE-20206E98D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944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8B8C40-27BD-4BFC-9218-92560E2DC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862C39-853F-4438-BA90-7FBBB8CF73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4A48B1-0AE1-44F7-92CD-ED93CF835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9A5C1A-8DB8-4A8A-B0FB-D917F05F6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405D5D-3F09-43DC-BF99-97778F860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2796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316095-0592-4618-803C-B6F73B65CD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895782-3AE6-4FBC-B1BD-E9F00C702A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F9B1C1-CF17-4F07-AB74-F78EFD8E34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44BA0FC-CF6D-40CE-B911-44A7E21E5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6A8654-5DF7-4C24-BD78-F46D43BC5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180128-9A4E-4180-95DC-A7D77C990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769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9D9E43-158A-49CF-A59D-377F62503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837366-6849-4928-BF66-47A605DDC6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4BF0D4-1778-433B-A716-566BC0DAD7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2349CB5-2FC4-44C2-88A7-36A119EF23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D9EBF59-CD58-452E-8077-FC217378A3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4EF3CA-9D1D-4347-9492-1C4CA48D9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E8BA9D4-9079-46C0-95F8-53E6562A8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ECBE720-2D2E-44DB-9651-0B0B5397D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301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70C54E-2FA2-41F9-8D99-DA81388C20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6223DD9-725E-4DF1-8C12-42A2E49D7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FFF375E-5E7C-42B9-BC3C-D3AB7106F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24D5BEB-AC66-4E39-89BE-471256BA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147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EC64036-5B14-435A-8C9D-16D7BCE8A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4320FC1-5371-4D8E-A936-B56749F4A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6F4BBD0-5471-4734-8502-9CBC49D0F6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8724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B1E386-1F27-44FA-BFF3-4674D988A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9FB6A9-D1BC-49E7-9305-AA537F86A8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AF193FB-C5AA-42DF-B4F9-CC3ADCD818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7B9AAE-DEB0-4BF4-9C51-FF6F3E3F3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B6A7F1-85B1-44FA-881D-AE12CC89C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E63251-833A-42CF-BDE4-7DD63776E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691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22A72E-9093-49DA-8A13-03B2409B6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B36926C-72D3-4C6A-ACF2-48AE249E8E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E2BD73D-1795-45B8-9D08-AA3D1F05F2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78BC92-118E-447E-A3AD-619E079BC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152732-4D9C-4877-B429-24A897726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965AC3-25AA-486A-A587-4820D5F6A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063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1027485-C09D-47FE-93F4-5AD5E5A6B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96E559-509A-4B40-897F-C5228BE54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4BFAC8-BBAF-46EF-9C36-E6F04C4A6B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A02F8-796B-4F7A-9899-8E59E2FB88B6}" type="datetimeFigureOut">
              <a:rPr lang="zh-CN" altLang="en-US" smtClean="0"/>
              <a:t>2024/9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174F83-AECE-41E9-B446-138AD00035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C8DA23-87B4-472B-8B11-D4E8B10ECF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5B81A7-9E5D-4F25-B7EA-891C3DF447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855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"/><Relationship Id="rId3" Type="http://schemas.openxmlformats.org/officeDocument/2006/relationships/image" Target="../media/image10.tif"/><Relationship Id="rId7" Type="http://schemas.openxmlformats.org/officeDocument/2006/relationships/image" Target="../media/image14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tif"/><Relationship Id="rId5" Type="http://schemas.openxmlformats.org/officeDocument/2006/relationships/image" Target="../media/image12.tif"/><Relationship Id="rId4" Type="http://schemas.openxmlformats.org/officeDocument/2006/relationships/image" Target="../media/image11.tif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13" Type="http://schemas.openxmlformats.org/officeDocument/2006/relationships/image" Target="../media/image21.png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12" Type="http://schemas.openxmlformats.org/officeDocument/2006/relationships/image" Target="../media/image20.tif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image" Target="../media/image19.tif"/><Relationship Id="rId5" Type="http://schemas.openxmlformats.org/officeDocument/2006/relationships/tags" Target="../tags/tag5.xml"/><Relationship Id="rId10" Type="http://schemas.openxmlformats.org/officeDocument/2006/relationships/image" Target="../media/image18.tif"/><Relationship Id="rId4" Type="http://schemas.openxmlformats.org/officeDocument/2006/relationships/tags" Target="../tags/tag4.xml"/><Relationship Id="rId9" Type="http://schemas.openxmlformats.org/officeDocument/2006/relationships/image" Target="../media/image17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tags" Target="../tags/tag10.xml"/><Relationship Id="rId7" Type="http://schemas.openxmlformats.org/officeDocument/2006/relationships/slideLayout" Target="../slideLayouts/slideLayout1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tags" Target="../tags/tag13.xml"/><Relationship Id="rId11" Type="http://schemas.openxmlformats.org/officeDocument/2006/relationships/image" Target="../media/image21.png"/><Relationship Id="rId5" Type="http://schemas.openxmlformats.org/officeDocument/2006/relationships/tags" Target="../tags/tag12.xml"/><Relationship Id="rId10" Type="http://schemas.openxmlformats.org/officeDocument/2006/relationships/image" Target="../media/image24.tif"/><Relationship Id="rId4" Type="http://schemas.openxmlformats.org/officeDocument/2006/relationships/tags" Target="../tags/tag11.xml"/><Relationship Id="rId9" Type="http://schemas.openxmlformats.org/officeDocument/2006/relationships/image" Target="../media/image2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57C0E71-7062-4170-9EA3-55555F7D2F03}"/>
              </a:ext>
            </a:extLst>
          </p:cNvPr>
          <p:cNvSpPr txBox="1"/>
          <p:nvPr/>
        </p:nvSpPr>
        <p:spPr>
          <a:xfrm>
            <a:off x="99151" y="143218"/>
            <a:ext cx="1057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.4b</a:t>
            </a:r>
            <a:endParaRPr lang="zh-CN" altLang="en-US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4254AC5E-50A9-4764-8666-B41FDE4E15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3233" y="405003"/>
            <a:ext cx="6162982" cy="1446798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51ED6275-B423-4DA6-8D12-9FBC2DE44E75}"/>
              </a:ext>
            </a:extLst>
          </p:cNvPr>
          <p:cNvSpPr/>
          <p:nvPr/>
        </p:nvSpPr>
        <p:spPr>
          <a:xfrm>
            <a:off x="4244724" y="1128402"/>
            <a:ext cx="2949290" cy="57921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63053598-029E-4373-A5BA-6F542284E04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3232" y="2652759"/>
            <a:ext cx="6162981" cy="1418379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C2F59E81-0984-4EB3-B4A0-4D7A44CCC7EB}"/>
              </a:ext>
            </a:extLst>
          </p:cNvPr>
          <p:cNvSpPr/>
          <p:nvPr/>
        </p:nvSpPr>
        <p:spPr>
          <a:xfrm>
            <a:off x="2787266" y="2944348"/>
            <a:ext cx="2431497" cy="62511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4C9BBB0-0EE8-4072-965E-3D45FD47A4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3232" y="4621397"/>
            <a:ext cx="6162980" cy="1523381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914EFE03-011C-499B-AB54-161DB9BE25A7}"/>
              </a:ext>
            </a:extLst>
          </p:cNvPr>
          <p:cNvSpPr/>
          <p:nvPr/>
        </p:nvSpPr>
        <p:spPr>
          <a:xfrm>
            <a:off x="1295432" y="4803875"/>
            <a:ext cx="2949290" cy="57921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7AF4C767-47B4-49E2-A6BA-6E202FD9DE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53329" y="203587"/>
            <a:ext cx="3834100" cy="1504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2759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FD2E0D6-6C46-4678-9693-CC226D40C936}"/>
              </a:ext>
            </a:extLst>
          </p:cNvPr>
          <p:cNvSpPr txBox="1"/>
          <p:nvPr/>
        </p:nvSpPr>
        <p:spPr>
          <a:xfrm>
            <a:off x="-55087" y="55082"/>
            <a:ext cx="1057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. 5d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84C49C0-4EA3-451F-AEC1-0EF682891F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503" y="115946"/>
            <a:ext cx="9189231" cy="185607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B372883D-C873-4989-959C-CA8FC0B5CB91}"/>
              </a:ext>
            </a:extLst>
          </p:cNvPr>
          <p:cNvSpPr/>
          <p:nvPr/>
        </p:nvSpPr>
        <p:spPr>
          <a:xfrm>
            <a:off x="5632845" y="875561"/>
            <a:ext cx="3147593" cy="65578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C513BD9-65AC-45AF-9287-8564B2359D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502" y="2256180"/>
            <a:ext cx="9189231" cy="2175985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83CE34BC-A9A8-48A0-AFA0-109376923DBA}"/>
              </a:ext>
            </a:extLst>
          </p:cNvPr>
          <p:cNvSpPr/>
          <p:nvPr/>
        </p:nvSpPr>
        <p:spPr>
          <a:xfrm>
            <a:off x="5676913" y="2666353"/>
            <a:ext cx="3147593" cy="65578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5F5342D-F967-4BCE-966B-3F82BC58B71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553" y="4738359"/>
            <a:ext cx="5769749" cy="1180918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867088CF-0744-48C2-BF5D-4E3285F5B8FF}"/>
              </a:ext>
            </a:extLst>
          </p:cNvPr>
          <p:cNvSpPr/>
          <p:nvPr/>
        </p:nvSpPr>
        <p:spPr>
          <a:xfrm>
            <a:off x="2496269" y="4930042"/>
            <a:ext cx="3147593" cy="655785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C3C375E3-8A39-43CF-8F00-F39C9A5F5E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98483" y="4727431"/>
            <a:ext cx="3238500" cy="198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322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BABB64D-2362-4DF9-BA6D-21DBDFDC1AB1}"/>
              </a:ext>
            </a:extLst>
          </p:cNvPr>
          <p:cNvSpPr txBox="1"/>
          <p:nvPr/>
        </p:nvSpPr>
        <p:spPr>
          <a:xfrm>
            <a:off x="154236" y="275422"/>
            <a:ext cx="1057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 6e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123B709-A16F-426E-B51A-8D8613849D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424" y="5887"/>
            <a:ext cx="5520681" cy="1079427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56072A66-4F32-450A-8A81-986991D03920}"/>
              </a:ext>
            </a:extLst>
          </p:cNvPr>
          <p:cNvSpPr/>
          <p:nvPr/>
        </p:nvSpPr>
        <p:spPr>
          <a:xfrm>
            <a:off x="2614228" y="239725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4D58717-7DA4-4FBF-9298-4B6406607381}"/>
              </a:ext>
            </a:extLst>
          </p:cNvPr>
          <p:cNvSpPr txBox="1"/>
          <p:nvPr/>
        </p:nvSpPr>
        <p:spPr>
          <a:xfrm>
            <a:off x="7348251" y="151589"/>
            <a:ext cx="49796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On both sides of the main strip are protective lanes (protecting the core lane strip from deformation)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78CB4E0-0DF4-46D2-8384-82AE4184C2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423" y="1120845"/>
            <a:ext cx="3641689" cy="729559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F4D5EF6C-29AE-40E3-985A-FD9111B2A5BB}"/>
              </a:ext>
            </a:extLst>
          </p:cNvPr>
          <p:cNvSpPr/>
          <p:nvPr/>
        </p:nvSpPr>
        <p:spPr>
          <a:xfrm>
            <a:off x="3504758" y="1196354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FCBA55C-76EC-4864-A8CB-DD7CF123A1F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419" y="1888688"/>
            <a:ext cx="4799154" cy="1079426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4A548D31-83DE-424E-B66F-C9A9A84BC6EE}"/>
              </a:ext>
            </a:extLst>
          </p:cNvPr>
          <p:cNvSpPr/>
          <p:nvPr/>
        </p:nvSpPr>
        <p:spPr>
          <a:xfrm>
            <a:off x="4494446" y="2097897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15C9B50-EF48-426C-9F66-6355F873823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418" y="2997292"/>
            <a:ext cx="5822103" cy="1079426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2C4AA7E9-7495-45A7-BED0-0C77B166D368}"/>
              </a:ext>
            </a:extLst>
          </p:cNvPr>
          <p:cNvSpPr/>
          <p:nvPr/>
        </p:nvSpPr>
        <p:spPr>
          <a:xfrm>
            <a:off x="5891750" y="3407067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649269B7-DD7A-48AD-8657-DC2C926A750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7417" y="4103985"/>
            <a:ext cx="5184057" cy="928050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5720C521-9BBA-4E17-8E1C-C85B6FAF98DD}"/>
              </a:ext>
            </a:extLst>
          </p:cNvPr>
          <p:cNvSpPr/>
          <p:nvPr/>
        </p:nvSpPr>
        <p:spPr>
          <a:xfrm>
            <a:off x="4395730" y="4270110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65D2E5B2-1A21-494E-8184-44865EEAD7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8434" y="5067941"/>
            <a:ext cx="4523046" cy="1096597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3783B34A-F300-4738-B838-C27748A10CD8}"/>
              </a:ext>
            </a:extLst>
          </p:cNvPr>
          <p:cNvSpPr/>
          <p:nvPr/>
        </p:nvSpPr>
        <p:spPr>
          <a:xfrm>
            <a:off x="2245601" y="5325891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3DC7B121-62BA-4409-9C0E-E7851CC9275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0745" y="6195603"/>
            <a:ext cx="3583282" cy="641283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B97EE048-D34A-4BC0-B6D1-86E4BE04CD91}"/>
              </a:ext>
            </a:extLst>
          </p:cNvPr>
          <p:cNvSpPr/>
          <p:nvPr/>
        </p:nvSpPr>
        <p:spPr>
          <a:xfrm>
            <a:off x="2563255" y="6260485"/>
            <a:ext cx="1197610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A620630-46BB-42E4-9A02-8E342F2F9D07}"/>
              </a:ext>
            </a:extLst>
          </p:cNvPr>
          <p:cNvSpPr txBox="1"/>
          <p:nvPr/>
        </p:nvSpPr>
        <p:spPr>
          <a:xfrm>
            <a:off x="5891750" y="6467554"/>
            <a:ext cx="6091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e two lanes on the left are bad lanes and protective lanes</a:t>
            </a:r>
            <a:endParaRPr lang="zh-CN" altLang="en-US" dirty="0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64B4F431-9E0D-40CA-9EEC-53B1E6B9F67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97809" y="2060630"/>
            <a:ext cx="2581275" cy="2952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581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/>
          <p:cNvSpPr txBox="1"/>
          <p:nvPr>
            <p:custDataLst>
              <p:tags r:id="rId1"/>
            </p:custDataLst>
          </p:nvPr>
        </p:nvSpPr>
        <p:spPr>
          <a:xfrm>
            <a:off x="1195425" y="1694255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>
                <a:solidFill>
                  <a:schemeClr val="tx1"/>
                </a:solidFill>
                <a:sym typeface="+mn-ea"/>
              </a:rPr>
              <a:t>p-RIP1</a:t>
            </a:r>
          </a:p>
        </p:txBody>
      </p:sp>
      <p:sp>
        <p:nvSpPr>
          <p:cNvPr id="39" name="文本框 38"/>
          <p:cNvSpPr txBox="1"/>
          <p:nvPr>
            <p:custDataLst>
              <p:tags r:id="rId2"/>
            </p:custDataLst>
          </p:nvPr>
        </p:nvSpPr>
        <p:spPr>
          <a:xfrm>
            <a:off x="1195425" y="2827052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t-RIP1</a:t>
            </a:r>
          </a:p>
        </p:txBody>
      </p:sp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1195426" y="4128441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solidFill>
                  <a:schemeClr val="tx1"/>
                </a:solidFill>
                <a:sym typeface="+mn-ea"/>
              </a:rPr>
              <a:t>p-RIP3</a:t>
            </a:r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1195427" y="5598422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t-RIP3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A4AA89-626E-4C77-87CD-49F28E09006C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4143977" y="709295"/>
            <a:ext cx="132842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/>
              <a:t>MPTP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52F05EC-949C-41BE-A711-936AFDA653FD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2832366" y="713422"/>
            <a:ext cx="11360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aline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9811A00-3A6C-4C03-AE7B-21ACBD116210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>
            <a:off x="5348339" y="710882"/>
            <a:ext cx="13284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MPTP + Nec-1s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7A12283-A839-4A27-9AB3-51C1F26D2060}"/>
              </a:ext>
            </a:extLst>
          </p:cNvPr>
          <p:cNvSpPr txBox="1"/>
          <p:nvPr/>
        </p:nvSpPr>
        <p:spPr>
          <a:xfrm>
            <a:off x="0" y="-42158"/>
            <a:ext cx="1057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 7g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C8D7440-21E3-44A6-9569-284B82A7A60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1564" y="1174776"/>
            <a:ext cx="4824945" cy="110357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8D81869-5CF4-4794-9A3F-655625F961E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745" y="2367342"/>
            <a:ext cx="4961826" cy="1220719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639A738-88BD-4D2F-B8C4-B91E6FB2175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1564" y="3671696"/>
            <a:ext cx="5140216" cy="125067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E759C56E-DD30-4024-B9D8-CD7342909EC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728" y="5023677"/>
            <a:ext cx="5253341" cy="1486677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DAD9A4D7-C2E0-4E44-96EB-64FCA94D83E9}"/>
              </a:ext>
            </a:extLst>
          </p:cNvPr>
          <p:cNvSpPr/>
          <p:nvPr/>
        </p:nvSpPr>
        <p:spPr>
          <a:xfrm>
            <a:off x="2838910" y="1488969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4A608026-AFB4-4FC4-A28F-492CC1E28F97}"/>
              </a:ext>
            </a:extLst>
          </p:cNvPr>
          <p:cNvSpPr/>
          <p:nvPr/>
        </p:nvSpPr>
        <p:spPr>
          <a:xfrm>
            <a:off x="2717514" y="2621766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E1A413C9-7EC4-41F8-BCC0-BC7EA77C932D}"/>
              </a:ext>
            </a:extLst>
          </p:cNvPr>
          <p:cNvSpPr/>
          <p:nvPr/>
        </p:nvSpPr>
        <p:spPr>
          <a:xfrm>
            <a:off x="2826896" y="3923155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1B63CE7C-CD93-4515-A18E-19DFB0A01B96}"/>
              </a:ext>
            </a:extLst>
          </p:cNvPr>
          <p:cNvSpPr/>
          <p:nvPr/>
        </p:nvSpPr>
        <p:spPr>
          <a:xfrm>
            <a:off x="2876824" y="5432536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88F5B83-6721-3D1C-26D8-E4134F01E08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6501" y="1488969"/>
            <a:ext cx="2621507" cy="1760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379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37"/>
          <p:cNvSpPr txBox="1"/>
          <p:nvPr>
            <p:custDataLst>
              <p:tags r:id="rId1"/>
            </p:custDataLst>
          </p:nvPr>
        </p:nvSpPr>
        <p:spPr>
          <a:xfrm>
            <a:off x="1426845" y="4486804"/>
            <a:ext cx="97790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600" b="1" dirty="0"/>
              <a:t>actin</a:t>
            </a:r>
          </a:p>
        </p:txBody>
      </p:sp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1402080" y="3051826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t-MLKL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3A4AA89-626E-4C77-87CD-49F28E09006C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4143977" y="709295"/>
            <a:ext cx="132842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/>
              <a:t>MPTP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52F05EC-949C-41BE-A711-936AFDA653FD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2832366" y="713422"/>
            <a:ext cx="11360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Saline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9811A00-3A6C-4C03-AE7B-21ACBD116210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5348339" y="710882"/>
            <a:ext cx="13284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MPTP + Nec-1s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676865E9-0BCD-4C0D-9775-085EF7AE9B1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514" y="4130215"/>
            <a:ext cx="4399691" cy="98780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7A12283-A839-4A27-9AB3-51C1F26D2060}"/>
              </a:ext>
            </a:extLst>
          </p:cNvPr>
          <p:cNvSpPr txBox="1"/>
          <p:nvPr/>
        </p:nvSpPr>
        <p:spPr>
          <a:xfrm>
            <a:off x="0" y="-42158"/>
            <a:ext cx="1057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 7g</a:t>
            </a:r>
            <a:endParaRPr lang="zh-CN" altLang="en-US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FCCCCC5-5ECC-492D-8BF9-C0D69ECFF1AF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1402080" y="2075458"/>
            <a:ext cx="10026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/>
              <a:t>p</a:t>
            </a:r>
            <a:r>
              <a:rPr lang="en-US" sz="1600" b="1" dirty="0"/>
              <a:t>-MLKL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86C5666-546C-4D65-AEB9-ECF11B053F2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745" y="1376964"/>
            <a:ext cx="5255232" cy="135013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84EA893-0DE2-4A2D-9945-1876E892528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4302" y="2871919"/>
            <a:ext cx="4720075" cy="1027167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49055580-FB9F-455E-83C0-848D0F040E5B}"/>
              </a:ext>
            </a:extLst>
          </p:cNvPr>
          <p:cNvSpPr/>
          <p:nvPr/>
        </p:nvSpPr>
        <p:spPr>
          <a:xfrm>
            <a:off x="2869732" y="1745819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B215A05C-4D99-4C34-AC7F-58977495F87D}"/>
              </a:ext>
            </a:extLst>
          </p:cNvPr>
          <p:cNvSpPr/>
          <p:nvPr/>
        </p:nvSpPr>
        <p:spPr>
          <a:xfrm>
            <a:off x="2869732" y="3064479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E4F730BC-20F8-4756-8893-9D75CC50268F}"/>
              </a:ext>
            </a:extLst>
          </p:cNvPr>
          <p:cNvSpPr/>
          <p:nvPr/>
        </p:nvSpPr>
        <p:spPr>
          <a:xfrm>
            <a:off x="2880005" y="4281518"/>
            <a:ext cx="3962581" cy="542471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dash"/>
              </a:ln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916F085-1EAE-79C3-625C-D45AE4DA585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2710" y="709295"/>
            <a:ext cx="2621507" cy="1760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87574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60</Words>
  <Application>Microsoft Office PowerPoint</Application>
  <PresentationFormat>宽屏</PresentationFormat>
  <Paragraphs>2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ongzhi Liu</cp:lastModifiedBy>
  <cp:revision>22</cp:revision>
  <dcterms:created xsi:type="dcterms:W3CDTF">2024-08-01T15:09:30Z</dcterms:created>
  <dcterms:modified xsi:type="dcterms:W3CDTF">2024-09-06T09:37:14Z</dcterms:modified>
</cp:coreProperties>
</file>